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5" r:id="rId2"/>
    <p:sldId id="267" r:id="rId3"/>
    <p:sldId id="26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E6A96B-7564-6743-A587-7AEB8C00BC05}" v="1" dt="2025-07-25T15:41:43.7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1348"/>
    <p:restoredTop sz="94758"/>
  </p:normalViewPr>
  <p:slideViewPr>
    <p:cSldViewPr snapToGrid="0">
      <p:cViewPr varScale="1">
        <p:scale>
          <a:sx n="92" d="100"/>
          <a:sy n="92" d="100"/>
        </p:scale>
        <p:origin x="184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80B2E0-D392-124F-857B-8B6259BDBC63}" type="datetimeFigureOut">
              <a:rPr lang="en-US" smtClean="0"/>
              <a:t>7/3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04E996-1285-1D46-BDE2-1065D68C2F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94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D856C1-0528-7D42-BB06-49DB551FB25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4847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982FB-2A0C-510A-9405-81F05A45CE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B9CABD-E1BD-F524-DFEF-E910D7FB96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C23010-FC26-2776-A7C3-990BCCD0A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69B209-7587-728E-1D6A-F9B53FF9B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272836-4BCE-5AB3-A80D-E49FD34C1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05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689CE-43E3-E509-2272-A06C379A8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5526E9-2EEA-45AE-FE6C-1691485AED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7E444-71B4-F573-EFC3-F22D23FE5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A94B07-3EEC-4792-6FA5-39CEE92D8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21C1A-ACB4-1495-FD9E-9DD3D1308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02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45C512E-AD82-E6A7-CFDC-A3EE0FA746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44B82D-7AA5-5C34-0DA1-F4D8C01FFF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44CA2-BD7B-52F9-E1BA-770B00443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D43C7-9A1E-26F9-3EB8-1E27932BA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4804A-759A-E3D2-E365-A837D5B78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601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37528-8A07-96A7-C562-09CD800BF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F7A5BB-2693-848A-F20F-218DAC17FD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D4BB43-BA84-F8B2-DC64-AC342D389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CE6A6-2E1A-0186-45A0-893696F13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1F6383-EB4E-1530-F2A3-DF95F4C13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9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2A986D-E8DE-CA65-05A5-EBAD65934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DFA020-1E3F-0FDC-2065-453953585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1F415-0DFF-10D4-F430-08535EA14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3B5AD-8F2A-B9C7-883C-346FDE3BA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4F206A-C753-10D8-961B-B54BFE46F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180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2E32DF-F7B0-C656-9449-C0524914E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CFC83B-04A5-7AFE-3095-8DE40DDBC5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89CFDE-19CE-14CF-6ACB-9B1D85462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F91673-E7BD-0FB2-9426-0F1889FE6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3A7E7E-C363-9500-5D60-556993330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748CC6-74D5-A287-7F5D-9CD38781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15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2220E-7676-B829-8758-BAD88FF3B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99174-E3EF-B7A3-BFAC-5F985CD3D6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E3CE6E-F2DD-3037-1EF7-D082399A8A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B388B0-2382-3840-7B1E-730406BB84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83E0BB-4114-6D2D-BBBE-CB36D51E9C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143C60-D269-57D6-0CBD-06D2095EE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6DAEE7-2AE9-58EE-A177-29A543BE6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B7D9DF-636D-7040-19F9-E2E7C0434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136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733B4-E54A-09B9-7309-6436B47BB3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B33476B-F1ED-4CE9-C7D3-1C6F22D5E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62E231-ED86-4405-33C7-B95D96B31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36EBFA-4B67-6EC6-E93D-E748646C6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891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10626E-5F91-A9CC-E0C9-6B6BED5CD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4C30D9-001B-4E34-810B-D665201EA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F0D2B2-BA21-9D32-4D95-823F73BF6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542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27ADC-AC12-9590-181E-3BACFB9A3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46B505-DC68-8389-72BC-DFB56A7052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6026BC-74E6-F572-B958-904E426DA6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9589CC-0942-ECDF-873F-1D5AEC45C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4B367C-B454-963B-32C8-7C50E1C0E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C8F7B-31BB-7607-C6A8-6F20DB38E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395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2AD4C-C15A-1F30-C841-D306B2FAB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45258C-2B2D-A790-7B85-5241956A0F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427311-A852-B51A-2C10-2F8DBE6167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905F12-4C6F-45BB-E7C1-C5CCBF0FD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A5F93E-0ABD-7B41-72A8-63701559D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81476A-7DFB-C6E3-DBDD-E5E16C5E4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397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3CA6CA-D19E-5CF7-0E42-EE35559807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1612BA-97C3-67A9-E1B9-C27E6663E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1E195-F2F3-44E4-5E2A-6B7CA096AA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B1A5B1-81F5-E248-9F00-302DAC5D2F5D}" type="datetimeFigureOut">
              <a:rPr lang="en-US" smtClean="0"/>
              <a:t>7/3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BD4C7C-3A2F-E0E1-E507-661732869C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F7326D-D2F1-B404-48AA-00F2C36C27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0ECA62-BA7E-3040-82A2-CF60FCB4B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431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22813A2-ED29-18DF-C061-D671E8031F8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0779" t="35962" r="8632" b="37007"/>
          <a:stretch/>
        </p:blipFill>
        <p:spPr>
          <a:xfrm>
            <a:off x="497959" y="1564500"/>
            <a:ext cx="5526804" cy="18536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668B1F-6A3D-90C7-E560-499122F0A15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9161" t="36293" r="10252" b="39108"/>
          <a:stretch/>
        </p:blipFill>
        <p:spPr>
          <a:xfrm>
            <a:off x="6156638" y="1588109"/>
            <a:ext cx="5526804" cy="16869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4CE7883-EF32-31F5-7988-CC05DD2C092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636" t="34024" r="10775" b="34712"/>
          <a:stretch/>
        </p:blipFill>
        <p:spPr>
          <a:xfrm>
            <a:off x="497959" y="3738144"/>
            <a:ext cx="5526804" cy="214411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D416318-E2AE-CF22-181C-E788B53240D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0779" t="35172" r="8632" b="33564"/>
          <a:stretch/>
        </p:blipFill>
        <p:spPr>
          <a:xfrm>
            <a:off x="6096000" y="3693807"/>
            <a:ext cx="5526804" cy="214411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C73550C-5011-F492-A272-A9E7FB4B38A9}"/>
              </a:ext>
            </a:extLst>
          </p:cNvPr>
          <p:cNvSpPr txBox="1"/>
          <p:nvPr/>
        </p:nvSpPr>
        <p:spPr>
          <a:xfrm>
            <a:off x="5165753" y="5497511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81FD49-C4BC-B33E-92F1-F7FDED1B3384}"/>
              </a:ext>
            </a:extLst>
          </p:cNvPr>
          <p:cNvSpPr txBox="1"/>
          <p:nvPr/>
        </p:nvSpPr>
        <p:spPr>
          <a:xfrm>
            <a:off x="10498778" y="528227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ß</a:t>
            </a:r>
            <a:r>
              <a:rPr lang="en-US" dirty="0"/>
              <a:t>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2B5081B-1619-A271-CA3F-31B0850B0A7A}"/>
              </a:ext>
            </a:extLst>
          </p:cNvPr>
          <p:cNvSpPr txBox="1"/>
          <p:nvPr/>
        </p:nvSpPr>
        <p:spPr>
          <a:xfrm>
            <a:off x="4315985" y="2933608"/>
            <a:ext cx="1532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B 807/81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F5C29F-E4FC-23B6-3681-79E82F38E324}"/>
              </a:ext>
            </a:extLst>
          </p:cNvPr>
          <p:cNvSpPr txBox="1"/>
          <p:nvPr/>
        </p:nvSpPr>
        <p:spPr>
          <a:xfrm>
            <a:off x="10943771" y="2869516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9D522EC-52C9-31E6-C142-981A06E3B900}"/>
              </a:ext>
            </a:extLst>
          </p:cNvPr>
          <p:cNvSpPr txBox="1"/>
          <p:nvPr/>
        </p:nvSpPr>
        <p:spPr>
          <a:xfrm>
            <a:off x="415410" y="175413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62A47B9-27EB-964E-FFC4-184FD21D91EE}"/>
              </a:ext>
            </a:extLst>
          </p:cNvPr>
          <p:cNvSpPr txBox="1"/>
          <p:nvPr/>
        </p:nvSpPr>
        <p:spPr>
          <a:xfrm>
            <a:off x="415410" y="2025012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CB336F-3382-4550-4F2B-24A263A8D162}"/>
              </a:ext>
            </a:extLst>
          </p:cNvPr>
          <p:cNvSpPr txBox="1"/>
          <p:nvPr/>
        </p:nvSpPr>
        <p:spPr>
          <a:xfrm>
            <a:off x="415410" y="2384422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91F6B89-624F-68C4-AC1E-18A8C433DAF3}"/>
              </a:ext>
            </a:extLst>
          </p:cNvPr>
          <p:cNvSpPr txBox="1"/>
          <p:nvPr/>
        </p:nvSpPr>
        <p:spPr>
          <a:xfrm>
            <a:off x="464250" y="2684378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6E8299-EA68-F44B-5B4E-E9119313C1C4}"/>
              </a:ext>
            </a:extLst>
          </p:cNvPr>
          <p:cNvSpPr txBox="1"/>
          <p:nvPr/>
        </p:nvSpPr>
        <p:spPr>
          <a:xfrm>
            <a:off x="6097642" y="4672626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A797161-92C2-1BB2-DA24-294C43FDD4FD}"/>
              </a:ext>
            </a:extLst>
          </p:cNvPr>
          <p:cNvSpPr txBox="1"/>
          <p:nvPr/>
        </p:nvSpPr>
        <p:spPr>
          <a:xfrm>
            <a:off x="6077871" y="545821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383FDF-41A7-D6B4-F6FB-FC05AB4294FD}"/>
              </a:ext>
            </a:extLst>
          </p:cNvPr>
          <p:cNvSpPr txBox="1"/>
          <p:nvPr/>
        </p:nvSpPr>
        <p:spPr>
          <a:xfrm>
            <a:off x="6097642" y="4079114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A1085D7-2159-1556-65E0-207F0C8E567D}"/>
              </a:ext>
            </a:extLst>
          </p:cNvPr>
          <p:cNvSpPr txBox="1"/>
          <p:nvPr/>
        </p:nvSpPr>
        <p:spPr>
          <a:xfrm>
            <a:off x="6007134" y="1740039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7AF817-8BC9-B960-5A97-237E76E4A551}"/>
              </a:ext>
            </a:extLst>
          </p:cNvPr>
          <p:cNvSpPr txBox="1"/>
          <p:nvPr/>
        </p:nvSpPr>
        <p:spPr>
          <a:xfrm>
            <a:off x="6007134" y="202833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477AAC2-D9FE-467C-43D7-A1C46C95CEA6}"/>
              </a:ext>
            </a:extLst>
          </p:cNvPr>
          <p:cNvSpPr txBox="1"/>
          <p:nvPr/>
        </p:nvSpPr>
        <p:spPr>
          <a:xfrm>
            <a:off x="6007134" y="2378503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CC5884D-6BEA-B663-3988-881D61C245AC}"/>
              </a:ext>
            </a:extLst>
          </p:cNvPr>
          <p:cNvSpPr txBox="1"/>
          <p:nvPr/>
        </p:nvSpPr>
        <p:spPr>
          <a:xfrm>
            <a:off x="6055974" y="266575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651ED34-5950-30EB-206E-89D4573BC38D}"/>
              </a:ext>
            </a:extLst>
          </p:cNvPr>
          <p:cNvSpPr txBox="1"/>
          <p:nvPr/>
        </p:nvSpPr>
        <p:spPr>
          <a:xfrm>
            <a:off x="424158" y="449684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430BD43-7F1D-23CE-9116-C65D6D165543}"/>
              </a:ext>
            </a:extLst>
          </p:cNvPr>
          <p:cNvSpPr txBox="1"/>
          <p:nvPr/>
        </p:nvSpPr>
        <p:spPr>
          <a:xfrm>
            <a:off x="404387" y="532054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A6D0F2-58CC-777A-2864-41B5244D364F}"/>
              </a:ext>
            </a:extLst>
          </p:cNvPr>
          <p:cNvSpPr txBox="1"/>
          <p:nvPr/>
        </p:nvSpPr>
        <p:spPr>
          <a:xfrm>
            <a:off x="424158" y="394143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AD80ED0-56D8-021C-E99E-8601C16ADC4F}"/>
              </a:ext>
            </a:extLst>
          </p:cNvPr>
          <p:cNvSpPr txBox="1"/>
          <p:nvPr/>
        </p:nvSpPr>
        <p:spPr>
          <a:xfrm>
            <a:off x="47725" y="0"/>
            <a:ext cx="10055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6C</a:t>
            </a:r>
          </a:p>
        </p:txBody>
      </p:sp>
    </p:spTree>
    <p:extLst>
      <p:ext uri="{BB962C8B-B14F-4D97-AF65-F5344CB8AC3E}">
        <p14:creationId xmlns:p14="http://schemas.microsoft.com/office/powerpoint/2010/main" val="4057466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5EFCB3-4219-1240-37D0-8490CA6A858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779" t="9142" r="10779" b="66259"/>
          <a:stretch/>
        </p:blipFill>
        <p:spPr>
          <a:xfrm>
            <a:off x="818793" y="1530774"/>
            <a:ext cx="5379522" cy="16869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12557E0-81A6-2204-A073-8A9DFC1F9B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341" t="10086" r="11239" b="64513"/>
          <a:stretch/>
        </p:blipFill>
        <p:spPr>
          <a:xfrm>
            <a:off x="6247864" y="1503248"/>
            <a:ext cx="5515202" cy="174202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83998A3-13D4-2173-E869-27B8F333F02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9556" t="3449" r="12003" b="65286"/>
          <a:stretch/>
        </p:blipFill>
        <p:spPr>
          <a:xfrm>
            <a:off x="818793" y="3483238"/>
            <a:ext cx="5379522" cy="214411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909C8DC-B37E-4BD4-2D2E-98F25D9F1BB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328" t="4138" r="10230" b="64598"/>
          <a:stretch/>
        </p:blipFill>
        <p:spPr>
          <a:xfrm>
            <a:off x="6398558" y="3462746"/>
            <a:ext cx="5379523" cy="214411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2C8C74A-527A-A8E0-8CB2-770EFFE39162}"/>
              </a:ext>
            </a:extLst>
          </p:cNvPr>
          <p:cNvSpPr txBox="1"/>
          <p:nvPr/>
        </p:nvSpPr>
        <p:spPr>
          <a:xfrm>
            <a:off x="5414723" y="5258017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4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842269-5698-A201-3650-9DCC8F2F5780}"/>
              </a:ext>
            </a:extLst>
          </p:cNvPr>
          <p:cNvSpPr txBox="1"/>
          <p:nvPr/>
        </p:nvSpPr>
        <p:spPr>
          <a:xfrm>
            <a:off x="10904969" y="5179898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ß</a:t>
            </a:r>
            <a:r>
              <a:rPr lang="en-US" dirty="0"/>
              <a:t>-actin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4290E1-90FB-4117-DE4E-694804CA7470}"/>
              </a:ext>
            </a:extLst>
          </p:cNvPr>
          <p:cNvSpPr txBox="1"/>
          <p:nvPr/>
        </p:nvSpPr>
        <p:spPr>
          <a:xfrm>
            <a:off x="4739266" y="2879030"/>
            <a:ext cx="1532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B 807/81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C49399-BD8B-1934-0365-863645CDB85C}"/>
              </a:ext>
            </a:extLst>
          </p:cNvPr>
          <p:cNvSpPr txBox="1"/>
          <p:nvPr/>
        </p:nvSpPr>
        <p:spPr>
          <a:xfrm>
            <a:off x="11141413" y="2848417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14D189-3AE4-76A8-A38D-F516878C8D6C}"/>
              </a:ext>
            </a:extLst>
          </p:cNvPr>
          <p:cNvSpPr txBox="1"/>
          <p:nvPr/>
        </p:nvSpPr>
        <p:spPr>
          <a:xfrm>
            <a:off x="714660" y="1784029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28AE86C-2218-8532-F7A0-F27469DA46A1}"/>
              </a:ext>
            </a:extLst>
          </p:cNvPr>
          <p:cNvSpPr txBox="1"/>
          <p:nvPr/>
        </p:nvSpPr>
        <p:spPr>
          <a:xfrm>
            <a:off x="714660" y="205491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D257CB-8B80-955D-F51A-402CD9B63111}"/>
              </a:ext>
            </a:extLst>
          </p:cNvPr>
          <p:cNvSpPr txBox="1"/>
          <p:nvPr/>
        </p:nvSpPr>
        <p:spPr>
          <a:xfrm>
            <a:off x="714660" y="2377745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AACDE2-524C-75DA-56DD-810FB23C5583}"/>
              </a:ext>
            </a:extLst>
          </p:cNvPr>
          <p:cNvSpPr txBox="1"/>
          <p:nvPr/>
        </p:nvSpPr>
        <p:spPr>
          <a:xfrm>
            <a:off x="763500" y="2677701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3094385-D5F7-2B44-F8F5-1038AF7D8958}"/>
              </a:ext>
            </a:extLst>
          </p:cNvPr>
          <p:cNvSpPr txBox="1"/>
          <p:nvPr/>
        </p:nvSpPr>
        <p:spPr>
          <a:xfrm>
            <a:off x="6396892" y="431227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A144392-5254-6595-EA6D-18C78142BF72}"/>
              </a:ext>
            </a:extLst>
          </p:cNvPr>
          <p:cNvSpPr txBox="1"/>
          <p:nvPr/>
        </p:nvSpPr>
        <p:spPr>
          <a:xfrm>
            <a:off x="6377121" y="509787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75573A-24A6-D59E-CE59-4FF6AB11E292}"/>
              </a:ext>
            </a:extLst>
          </p:cNvPr>
          <p:cNvSpPr txBox="1"/>
          <p:nvPr/>
        </p:nvSpPr>
        <p:spPr>
          <a:xfrm>
            <a:off x="6396892" y="371876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BAA24E8-7933-23FC-AF34-DC9FC4A49011}"/>
              </a:ext>
            </a:extLst>
          </p:cNvPr>
          <p:cNvSpPr txBox="1"/>
          <p:nvPr/>
        </p:nvSpPr>
        <p:spPr>
          <a:xfrm>
            <a:off x="6247864" y="175530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CB8E73-082D-8CC5-046E-ABB1B49BC451}"/>
              </a:ext>
            </a:extLst>
          </p:cNvPr>
          <p:cNvSpPr txBox="1"/>
          <p:nvPr/>
        </p:nvSpPr>
        <p:spPr>
          <a:xfrm>
            <a:off x="6247864" y="204360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F32C3E-FB22-2674-49DF-F97D0BC77821}"/>
              </a:ext>
            </a:extLst>
          </p:cNvPr>
          <p:cNvSpPr txBox="1"/>
          <p:nvPr/>
        </p:nvSpPr>
        <p:spPr>
          <a:xfrm>
            <a:off x="6247864" y="236644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6C9ED8F-6C33-02CA-BCDF-F7CCF78AF6AC}"/>
              </a:ext>
            </a:extLst>
          </p:cNvPr>
          <p:cNvSpPr txBox="1"/>
          <p:nvPr/>
        </p:nvSpPr>
        <p:spPr>
          <a:xfrm>
            <a:off x="6296704" y="266639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082894-BCC4-10A1-804A-2B7ACC2275A3}"/>
              </a:ext>
            </a:extLst>
          </p:cNvPr>
          <p:cNvSpPr txBox="1"/>
          <p:nvPr/>
        </p:nvSpPr>
        <p:spPr>
          <a:xfrm>
            <a:off x="723408" y="4263502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5CA257-FC23-9027-5E6B-C0C176B39B67}"/>
              </a:ext>
            </a:extLst>
          </p:cNvPr>
          <p:cNvSpPr txBox="1"/>
          <p:nvPr/>
        </p:nvSpPr>
        <p:spPr>
          <a:xfrm>
            <a:off x="703637" y="504909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BF215CE-A92E-9F51-39CB-5AF973DAC631}"/>
              </a:ext>
            </a:extLst>
          </p:cNvPr>
          <p:cNvSpPr txBox="1"/>
          <p:nvPr/>
        </p:nvSpPr>
        <p:spPr>
          <a:xfrm>
            <a:off x="723408" y="3669990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EE29A6-37CB-C4A1-22F7-30C8028A26E0}"/>
              </a:ext>
            </a:extLst>
          </p:cNvPr>
          <p:cNvSpPr txBox="1"/>
          <p:nvPr/>
        </p:nvSpPr>
        <p:spPr>
          <a:xfrm>
            <a:off x="47725" y="0"/>
            <a:ext cx="42560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6C (Reps for quantification)</a:t>
            </a:r>
          </a:p>
        </p:txBody>
      </p:sp>
    </p:spTree>
    <p:extLst>
      <p:ext uri="{BB962C8B-B14F-4D97-AF65-F5344CB8AC3E}">
        <p14:creationId xmlns:p14="http://schemas.microsoft.com/office/powerpoint/2010/main" val="2341775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2E4948-D6CF-4D37-EB74-2F511B5322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10A0D483-7ECF-C837-5445-A79185E77947}"/>
              </a:ext>
            </a:extLst>
          </p:cNvPr>
          <p:cNvSpPr txBox="1"/>
          <p:nvPr/>
        </p:nvSpPr>
        <p:spPr>
          <a:xfrm>
            <a:off x="47725" y="0"/>
            <a:ext cx="45980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 6C (</a:t>
            </a:r>
            <a:r>
              <a:rPr lang="en-US" sz="2400" dirty="0" err="1"/>
              <a:t>Bioreps</a:t>
            </a:r>
            <a:r>
              <a:rPr lang="en-US" sz="2400" dirty="0"/>
              <a:t> for quantification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7ACC2AF-C091-6E22-6718-A98B73B361F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1558" t="64632" r="10000" b="9595"/>
          <a:stretch/>
        </p:blipFill>
        <p:spPr>
          <a:xfrm>
            <a:off x="834887" y="1273431"/>
            <a:ext cx="5379522" cy="176744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660FB36-FA2D-A1A7-9417-55C06063123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161" t="62886" r="12399" b="11342"/>
          <a:stretch/>
        </p:blipFill>
        <p:spPr>
          <a:xfrm>
            <a:off x="6395932" y="1273431"/>
            <a:ext cx="5379522" cy="176744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0DD9B37-7DC3-481F-18D9-D0920D7B370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406" t="63576" r="13152" b="1260"/>
          <a:stretch/>
        </p:blipFill>
        <p:spPr>
          <a:xfrm>
            <a:off x="834887" y="3222117"/>
            <a:ext cx="5379522" cy="241154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14705F8-3DE1-8291-DC2C-FC3BE493BC0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400" t="68366" r="10159" b="2669"/>
          <a:stretch/>
        </p:blipFill>
        <p:spPr>
          <a:xfrm>
            <a:off x="6395932" y="3315001"/>
            <a:ext cx="5379522" cy="198645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1B575D94-DE4B-88DC-1F55-FEFA75D651F7}"/>
              </a:ext>
            </a:extLst>
          </p:cNvPr>
          <p:cNvSpPr txBox="1"/>
          <p:nvPr/>
        </p:nvSpPr>
        <p:spPr>
          <a:xfrm>
            <a:off x="5455868" y="5215237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FB1327-E47D-2B4A-76C5-B9438565B6AC}"/>
              </a:ext>
            </a:extLst>
          </p:cNvPr>
          <p:cNvSpPr txBox="1"/>
          <p:nvPr/>
        </p:nvSpPr>
        <p:spPr>
          <a:xfrm>
            <a:off x="10885467" y="4856110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ß</a:t>
            </a:r>
            <a:r>
              <a:rPr lang="en-US" dirty="0"/>
              <a:t>-acti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16F4DA3-667B-1064-7AB6-DF6D175ED4F1}"/>
              </a:ext>
            </a:extLst>
          </p:cNvPr>
          <p:cNvSpPr txBox="1"/>
          <p:nvPr/>
        </p:nvSpPr>
        <p:spPr>
          <a:xfrm>
            <a:off x="4681745" y="2639432"/>
            <a:ext cx="1532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RB 807/81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6353A7E-74CE-2F00-C262-31A8BC42B0EA}"/>
              </a:ext>
            </a:extLst>
          </p:cNvPr>
          <p:cNvSpPr txBox="1"/>
          <p:nvPr/>
        </p:nvSpPr>
        <p:spPr>
          <a:xfrm>
            <a:off x="11198543" y="2671544"/>
            <a:ext cx="463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069A9EE-53F0-AE70-39E1-9C33F5785289}"/>
              </a:ext>
            </a:extLst>
          </p:cNvPr>
          <p:cNvSpPr txBox="1"/>
          <p:nvPr/>
        </p:nvSpPr>
        <p:spPr>
          <a:xfrm>
            <a:off x="706210" y="159041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30B64D-AA8B-5B0C-A022-F0A8D97BFEB6}"/>
              </a:ext>
            </a:extLst>
          </p:cNvPr>
          <p:cNvSpPr txBox="1"/>
          <p:nvPr/>
        </p:nvSpPr>
        <p:spPr>
          <a:xfrm>
            <a:off x="706210" y="188535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CD2839D-9041-D366-C461-F527EC6D5159}"/>
              </a:ext>
            </a:extLst>
          </p:cNvPr>
          <p:cNvSpPr txBox="1"/>
          <p:nvPr/>
        </p:nvSpPr>
        <p:spPr>
          <a:xfrm>
            <a:off x="706210" y="224476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40A63DB-7604-F20A-2C26-3F46ECDC3DDD}"/>
              </a:ext>
            </a:extLst>
          </p:cNvPr>
          <p:cNvSpPr txBox="1"/>
          <p:nvPr/>
        </p:nvSpPr>
        <p:spPr>
          <a:xfrm>
            <a:off x="755050" y="2508627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1A3AB9D-5226-5A5D-B662-F41F714407FF}"/>
              </a:ext>
            </a:extLst>
          </p:cNvPr>
          <p:cNvSpPr txBox="1"/>
          <p:nvPr/>
        </p:nvSpPr>
        <p:spPr>
          <a:xfrm>
            <a:off x="6319877" y="402920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8EE1AA-E1DD-6A8E-6C5E-15807C1DB946}"/>
              </a:ext>
            </a:extLst>
          </p:cNvPr>
          <p:cNvSpPr txBox="1"/>
          <p:nvPr/>
        </p:nvSpPr>
        <p:spPr>
          <a:xfrm>
            <a:off x="6300106" y="4814796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8B4D7DD-C36D-2EB2-825F-68EAA7C8B07B}"/>
              </a:ext>
            </a:extLst>
          </p:cNvPr>
          <p:cNvSpPr txBox="1"/>
          <p:nvPr/>
        </p:nvSpPr>
        <p:spPr>
          <a:xfrm>
            <a:off x="6319877" y="343569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FB499B0-C16C-95D3-1522-8B7A274CA2D7}"/>
              </a:ext>
            </a:extLst>
          </p:cNvPr>
          <p:cNvSpPr txBox="1"/>
          <p:nvPr/>
        </p:nvSpPr>
        <p:spPr>
          <a:xfrm>
            <a:off x="6267303" y="135498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0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4138123-F49A-4133-A228-489DF403E949}"/>
              </a:ext>
            </a:extLst>
          </p:cNvPr>
          <p:cNvSpPr txBox="1"/>
          <p:nvPr/>
        </p:nvSpPr>
        <p:spPr>
          <a:xfrm>
            <a:off x="6267303" y="164328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50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6F55BE3-BA39-74D3-8539-A9FB56E037BB}"/>
              </a:ext>
            </a:extLst>
          </p:cNvPr>
          <p:cNvSpPr txBox="1"/>
          <p:nvPr/>
        </p:nvSpPr>
        <p:spPr>
          <a:xfrm>
            <a:off x="6267303" y="202034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00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162C643-B42F-5040-0845-9D584DEF8890}"/>
              </a:ext>
            </a:extLst>
          </p:cNvPr>
          <p:cNvSpPr txBox="1"/>
          <p:nvPr/>
        </p:nvSpPr>
        <p:spPr>
          <a:xfrm>
            <a:off x="6316143" y="2307603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75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D6A3F7C-D53B-0337-91A4-0C365AF49232}"/>
              </a:ext>
            </a:extLst>
          </p:cNvPr>
          <p:cNvSpPr txBox="1"/>
          <p:nvPr/>
        </p:nvSpPr>
        <p:spPr>
          <a:xfrm>
            <a:off x="798386" y="4018568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37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1D498BF-BC2F-C449-B3E4-879A0AD020B3}"/>
              </a:ext>
            </a:extLst>
          </p:cNvPr>
          <p:cNvSpPr txBox="1"/>
          <p:nvPr/>
        </p:nvSpPr>
        <p:spPr>
          <a:xfrm>
            <a:off x="778615" y="4842259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25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3352AD2-6C1B-AB3D-4081-63099AA1F3BD}"/>
              </a:ext>
            </a:extLst>
          </p:cNvPr>
          <p:cNvSpPr txBox="1"/>
          <p:nvPr/>
        </p:nvSpPr>
        <p:spPr>
          <a:xfrm>
            <a:off x="798386" y="3406885"/>
            <a:ext cx="383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50-</a:t>
            </a:r>
          </a:p>
        </p:txBody>
      </p:sp>
    </p:spTree>
    <p:extLst>
      <p:ext uri="{BB962C8B-B14F-4D97-AF65-F5344CB8AC3E}">
        <p14:creationId xmlns:p14="http://schemas.microsoft.com/office/powerpoint/2010/main" val="388733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3</TotalTime>
  <Words>74</Words>
  <Application>Microsoft Macintosh PowerPoint</Application>
  <PresentationFormat>Widescreen</PresentationFormat>
  <Paragraphs>5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i, Chun Fui</dc:creator>
  <cp:lastModifiedBy>Ali, Simak</cp:lastModifiedBy>
  <cp:revision>27</cp:revision>
  <dcterms:created xsi:type="dcterms:W3CDTF">2024-08-20T10:33:57Z</dcterms:created>
  <dcterms:modified xsi:type="dcterms:W3CDTF">2025-07-30T14:29:37Z</dcterms:modified>
</cp:coreProperties>
</file>